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95" d="100"/>
          <a:sy n="95" d="100"/>
        </p:scale>
        <p:origin x="241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643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8682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623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017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9699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2550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159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627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3395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6800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870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1D7C29-56B9-44C1-ACDD-10032A9B2BC4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4A7A5-0B8D-452A-8F86-738184DCE0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472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1" t="12874" r="3609" b="12822"/>
          <a:stretch/>
        </p:blipFill>
        <p:spPr bwMode="auto">
          <a:xfrm>
            <a:off x="355870" y="1277951"/>
            <a:ext cx="3859644" cy="38795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55870" y="939397"/>
            <a:ext cx="2438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rinary Frequency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9" t="11474" r="3104" b="12950"/>
          <a:stretch/>
        </p:blipFill>
        <p:spPr bwMode="auto">
          <a:xfrm>
            <a:off x="314879" y="5496043"/>
            <a:ext cx="3941626" cy="39526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450464" y="5157489"/>
            <a:ext cx="9605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cturia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14879" y="139178"/>
            <a:ext cx="639742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2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Receiver Operating Characteristic (ROC) curves for urinary frequency and nocturia in relation to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TI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459076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23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ghenekome Gibinigie</dc:creator>
  <cp:lastModifiedBy>Oghenekome Gibinigie</cp:lastModifiedBy>
  <cp:revision>6</cp:revision>
  <dcterms:created xsi:type="dcterms:W3CDTF">2017-03-02T11:59:39Z</dcterms:created>
  <dcterms:modified xsi:type="dcterms:W3CDTF">2017-12-05T16:50:51Z</dcterms:modified>
</cp:coreProperties>
</file>